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5982" autoAdjust="0"/>
  </p:normalViewPr>
  <p:slideViewPr>
    <p:cSldViewPr>
      <p:cViewPr varScale="1">
        <p:scale>
          <a:sx n="112" d="100"/>
          <a:sy n="112" d="100"/>
        </p:scale>
        <p:origin x="2536" y="1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2/2/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1800" b="1" i="1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ulti-task Deep Learning in myocardial blood flow and cardiovascular risk traits from PET myocardial perfusion imaging</a:t>
            </a:r>
            <a:endParaRPr lang="en-US" altLang="en-US" sz="7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990600" y="2558771"/>
            <a:ext cx="6934200" cy="12192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spcBef>
                <a:spcPts val="0"/>
              </a:spcBef>
            </a:pPr>
            <a:r>
              <a:rPr lang="nl-NL" sz="14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ing Wai Yeung</a:t>
            </a:r>
            <a:r>
              <a:rPr lang="nl-NL" sz="1400" b="1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,2</a:t>
            </a:r>
            <a:r>
              <a:rPr lang="nl-NL" sz="14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Jan Walter Benjamins</a:t>
            </a:r>
            <a:r>
              <a:rPr lang="nl-NL" sz="1400" b="1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nl-NL" sz="14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Remco JJ Knol MD, PhD</a:t>
            </a:r>
            <a:r>
              <a:rPr lang="nl-NL" sz="1400" b="1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nl-NL" sz="14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Friso M van der Zant MD, PhD</a:t>
            </a:r>
            <a:r>
              <a:rPr lang="nl-NL" sz="1400" b="1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 </a:t>
            </a:r>
            <a:r>
              <a:rPr lang="nl-NL" sz="14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</a:t>
            </a:r>
            <a:r>
              <a:rPr lang="nl-NL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4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lkert W Asselbergs, MD, PhD</a:t>
            </a:r>
            <a:r>
              <a:rPr lang="nl-NL" sz="1400" b="1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nl-NL" sz="14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Pim van der Harst MD, PhD</a:t>
            </a:r>
            <a:r>
              <a:rPr lang="nl-NL" sz="1400" b="1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,2</a:t>
            </a:r>
            <a:r>
              <a:rPr lang="nl-NL" sz="14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Luis Eduardo Juarez-Orozco MD, PhD</a:t>
            </a:r>
            <a:r>
              <a:rPr lang="nl-NL" sz="1400" b="1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nl-NL" sz="1400" b="1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2</a:t>
            </a:r>
            <a:endParaRPr lang="en-HK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 algn="l">
              <a:spcBef>
                <a:spcPts val="0"/>
              </a:spcBef>
              <a:buFont typeface="+mj-lt"/>
              <a:buAutoNum type="arabi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iversity of Groningen, University Medical Center Groningen, Department of Cardiology, 9700 RB Groningen, the Netherlands</a:t>
            </a:r>
            <a:endParaRPr lang="en-HK" sz="9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 algn="l">
              <a:spcBef>
                <a:spcPts val="0"/>
              </a:spcBef>
              <a:buFont typeface="+mj-lt"/>
              <a:buAutoNum type="arabicPeriod"/>
            </a:pPr>
            <a:r>
              <a:rPr lang="en-HK" sz="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Cardiology, Division of Heart &amp; Lungs, University Medical </a:t>
            </a:r>
            <a:r>
              <a:rPr lang="en-HK" sz="9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er</a:t>
            </a:r>
            <a:r>
              <a:rPr lang="en-HK" sz="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trecht, University of Utrecht, Utrecht, the Netherlands</a:t>
            </a:r>
            <a:endParaRPr lang="en-HK" sz="9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 algn="l">
              <a:spcBef>
                <a:spcPts val="0"/>
              </a:spcBef>
              <a:buFont typeface="+mj-lt"/>
              <a:buAutoNum type="arabicPeriod"/>
            </a:pPr>
            <a:r>
              <a:rPr lang="en-HK" sz="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rdiac Imaging Division Alkmaar, Northwest Clinics, Department of Nuclear Medicine, Alkmaar, The Netherlands</a:t>
            </a:r>
            <a:endParaRPr lang="en-HK" sz="9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en-US" sz="4000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1571147-E2F8-40BA-9390-31BB4089128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887317"/>
            <a:ext cx="1486266" cy="148626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9994A46-56C9-4D35-B276-99A2BFA00A3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3895" t="1435" r="6068" b="42030"/>
          <a:stretch/>
        </p:blipFill>
        <p:spPr>
          <a:xfrm>
            <a:off x="5821362" y="3887317"/>
            <a:ext cx="1577976" cy="1486266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800" dirty="0"/>
              <a:t>1- </a:t>
            </a:r>
            <a:r>
              <a:rPr lang="en-HK" sz="1800" b="0" dirty="0">
                <a:cs typeface="Helvetica" panose="020B0604020202020204" pitchFamily="34" charset="0"/>
              </a:rPr>
              <a:t>Positron emission tomography (PET</a:t>
            </a:r>
            <a:r>
              <a:rPr lang="en-HK" sz="1800" dirty="0">
                <a:cs typeface="Helvetica" panose="020B0604020202020204" pitchFamily="34" charset="0"/>
              </a:rPr>
              <a:t>) summarized in topographical polar maps allows </a:t>
            </a:r>
            <a:r>
              <a:rPr lang="en-HK" sz="1800" b="0" dirty="0">
                <a:cs typeface="Helvetica" panose="020B0604020202020204" pitchFamily="34" charset="0"/>
              </a:rPr>
              <a:t>quantitative evaluation of myocardial perfusion </a:t>
            </a:r>
          </a:p>
          <a:p>
            <a:pPr marL="0" indent="0">
              <a:buNone/>
            </a:pPr>
            <a:r>
              <a:rPr lang="en-US" altLang="en-US" sz="1800" dirty="0"/>
              <a:t>2- Deep learning (DL) constitutes a novel analytical tool for direct image evaluation</a:t>
            </a:r>
          </a:p>
          <a:p>
            <a:pPr marL="0" indent="0">
              <a:buNone/>
            </a:pPr>
            <a:r>
              <a:rPr lang="en-HK" sz="1800" b="0" dirty="0">
                <a:cs typeface="Helvetica" panose="020B0604020202020204" pitchFamily="34" charset="0"/>
              </a:rPr>
              <a:t>3- </a:t>
            </a:r>
            <a:r>
              <a:rPr lang="en-HK" altLang="en-US" sz="1800" dirty="0"/>
              <a:t>Studies on the implementation of Deep Learning (DL) for the identification of myocardial ischemia on PET imaging are scarce </a:t>
            </a:r>
          </a:p>
          <a:p>
            <a:pPr marL="0" indent="0">
              <a:buNone/>
            </a:pPr>
            <a:r>
              <a:rPr lang="en-HK" altLang="en-US" sz="1800" dirty="0"/>
              <a:t>4- </a:t>
            </a:r>
            <a:r>
              <a:rPr lang="en-HK" sz="1800" b="0" dirty="0">
                <a:cs typeface="Helvetica" panose="020B0604020202020204" pitchFamily="34" charset="0"/>
              </a:rPr>
              <a:t>It is unknown </a:t>
            </a:r>
            <a:r>
              <a:rPr lang="en-HK" sz="1800" dirty="0">
                <a:cs typeface="Helvetica" panose="020B0604020202020204" pitchFamily="34" charset="0"/>
              </a:rPr>
              <a:t>whether</a:t>
            </a:r>
            <a:r>
              <a:rPr lang="en-HK" sz="1800" b="0" dirty="0">
                <a:cs typeface="Helvetica" panose="020B0604020202020204" pitchFamily="34" charset="0"/>
              </a:rPr>
              <a:t> DL may provide </a:t>
            </a:r>
            <a:r>
              <a:rPr lang="en-HK" altLang="en-US" sz="1800" dirty="0"/>
              <a:t>insights into complex patterns associated with the presence of cardiovascular risk traits</a:t>
            </a:r>
            <a:endParaRPr lang="en-HK" sz="1800" b="0" dirty="0">
              <a:cs typeface="Helvetica" panose="020B0604020202020204" pitchFamily="34" charset="0"/>
            </a:endParaRPr>
          </a:p>
          <a:p>
            <a:pPr marL="0" indent="0">
              <a:buNone/>
            </a:pP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type:(</a:t>
            </a:r>
            <a:r>
              <a:rPr lang="en-US" altLang="en-US" sz="18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observational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subjects: 241 excluded due to missing data resulting in 944 subjects in final analysi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aim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HK" altLang="en-US" sz="1800" dirty="0"/>
              <a:t>Develop DL models with PET myocardial perfusion polar maps for detection of impaired myocardial flow reserve and cardiovascular risk traits on an individual-patient basi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HK" altLang="en-US" sz="1800" dirty="0"/>
              <a:t>Visualize the regions associated with corresponding model prediction in attention heatmap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Approach: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Transfer learning + multitasking learning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Occlusion sensitivity + </a:t>
            </a:r>
            <a:r>
              <a:rPr lang="en-US" altLang="en-US" sz="1800" dirty="0" err="1"/>
              <a:t>GradCAM</a:t>
            </a:r>
            <a:r>
              <a:rPr lang="en-US" altLang="en-US" sz="1800" dirty="0"/>
              <a:t> method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34154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CCFA9C4-0E4E-4BAF-89D9-4D2EFB18F8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7396658"/>
              </p:ext>
            </p:extLst>
          </p:nvPr>
        </p:nvGraphicFramePr>
        <p:xfrm>
          <a:off x="465633" y="1524000"/>
          <a:ext cx="8304173" cy="4499610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1638302">
                  <a:extLst>
                    <a:ext uri="{9D8B030D-6E8A-4147-A177-3AD203B41FA5}">
                      <a16:colId xmlns:a16="http://schemas.microsoft.com/office/drawing/2014/main" val="1962082221"/>
                    </a:ext>
                  </a:extLst>
                </a:gridCol>
                <a:gridCol w="1289539">
                  <a:extLst>
                    <a:ext uri="{9D8B030D-6E8A-4147-A177-3AD203B41FA5}">
                      <a16:colId xmlns:a16="http://schemas.microsoft.com/office/drawing/2014/main" val="447478303"/>
                    </a:ext>
                  </a:extLst>
                </a:gridCol>
                <a:gridCol w="1344083">
                  <a:extLst>
                    <a:ext uri="{9D8B030D-6E8A-4147-A177-3AD203B41FA5}">
                      <a16:colId xmlns:a16="http://schemas.microsoft.com/office/drawing/2014/main" val="3663899277"/>
                    </a:ext>
                  </a:extLst>
                </a:gridCol>
                <a:gridCol w="1344083">
                  <a:extLst>
                    <a:ext uri="{9D8B030D-6E8A-4147-A177-3AD203B41FA5}">
                      <a16:colId xmlns:a16="http://schemas.microsoft.com/office/drawing/2014/main" val="2599631289"/>
                    </a:ext>
                  </a:extLst>
                </a:gridCol>
                <a:gridCol w="1344083">
                  <a:extLst>
                    <a:ext uri="{9D8B030D-6E8A-4147-A177-3AD203B41FA5}">
                      <a16:colId xmlns:a16="http://schemas.microsoft.com/office/drawing/2014/main" val="1922311058"/>
                    </a:ext>
                  </a:extLst>
                </a:gridCol>
                <a:gridCol w="1344083">
                  <a:extLst>
                    <a:ext uri="{9D8B030D-6E8A-4147-A177-3AD203B41FA5}">
                      <a16:colId xmlns:a16="http://schemas.microsoft.com/office/drawing/2014/main" val="1608044653"/>
                    </a:ext>
                  </a:extLst>
                </a:gridCol>
              </a:tblGrid>
              <a:tr h="8382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dirty="0">
                          <a:effectLst/>
                        </a:rPr>
                        <a:t>Output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dirty="0">
                          <a:effectLst/>
                        </a:rPr>
                        <a:t>Prevalence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>
                          <a:effectLst/>
                        </a:rPr>
                        <a:t>AUC using Rest PM</a:t>
                      </a:r>
                      <a:endParaRPr lang="en-HK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dirty="0">
                          <a:effectLst/>
                        </a:rPr>
                        <a:t>AUC using Stress PM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dirty="0">
                          <a:effectLst/>
                        </a:rPr>
                        <a:t>AUC using Reserve PM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dirty="0">
                          <a:effectLst/>
                        </a:rPr>
                        <a:t>AUC using stacked PMs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 anchor="ctr"/>
                </a:tc>
                <a:extLst>
                  <a:ext uri="{0D108BD9-81ED-4DB2-BD59-A6C34878D82A}">
                    <a16:rowId xmlns:a16="http://schemas.microsoft.com/office/drawing/2014/main" val="692697514"/>
                  </a:ext>
                </a:extLst>
              </a:tr>
              <a:tr h="36601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dirty="0">
                          <a:effectLst/>
                        </a:rPr>
                        <a:t>Impaired MFR in any segment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dirty="0">
                          <a:effectLst/>
                        </a:rPr>
                        <a:t>67.50%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b="1" dirty="0">
                          <a:effectLst/>
                        </a:rPr>
                        <a:t>0.68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HK" sz="1600" b="1" dirty="0">
                          <a:effectLst/>
                        </a:rPr>
                        <a:t>(0.57 - 0.78)</a:t>
                      </a:r>
                      <a:endParaRPr lang="en-HK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b="1" dirty="0">
                          <a:effectLst/>
                        </a:rPr>
                        <a:t>0.68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HK" sz="1600" b="1" dirty="0">
                          <a:effectLst/>
                        </a:rPr>
                        <a:t>(0.55 - 0.79)</a:t>
                      </a:r>
                      <a:endParaRPr lang="en-HK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b="1" dirty="0">
                          <a:effectLst/>
                        </a:rPr>
                        <a:t>0.94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HK" sz="1600" b="1" dirty="0">
                          <a:effectLst/>
                        </a:rPr>
                        <a:t>(0.87 - 0.98)</a:t>
                      </a:r>
                      <a:endParaRPr lang="en-HK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HK" sz="1600" b="1" dirty="0">
                          <a:effectLst/>
                        </a:rPr>
                        <a:t>0.9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HK" sz="1600" b="1" dirty="0">
                          <a:effectLst/>
                        </a:rPr>
                        <a:t>(0.82 - 0.96)</a:t>
                      </a:r>
                    </a:p>
                  </a:txBody>
                  <a:tcPr marL="45546" marR="45546" marT="0" marB="0"/>
                </a:tc>
                <a:extLst>
                  <a:ext uri="{0D108BD9-81ED-4DB2-BD59-A6C34878D82A}">
                    <a16:rowId xmlns:a16="http://schemas.microsoft.com/office/drawing/2014/main" val="120779859"/>
                  </a:ext>
                </a:extLst>
              </a:tr>
              <a:tr h="41902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Diabetes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15.4%</a:t>
                      </a:r>
                      <a:endParaRPr lang="en-HK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0.62</a:t>
                      </a:r>
                      <a:endParaRPr lang="en-HK" sz="16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(0.50 - 0.75)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0.62</a:t>
                      </a:r>
                      <a:endParaRPr lang="en-HK" sz="16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(0.49 - 0.75)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0.65</a:t>
                      </a:r>
                      <a:endParaRPr lang="en-HK" sz="1600" b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(0.51 - 0.79)</a:t>
                      </a:r>
                      <a:endParaRPr lang="en-HK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0.52</a:t>
                      </a:r>
                      <a:endParaRPr lang="en-HK" sz="16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(0.38 - 0.66)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extLst>
                  <a:ext uri="{0D108BD9-81ED-4DB2-BD59-A6C34878D82A}">
                    <a16:rowId xmlns:a16="http://schemas.microsoft.com/office/drawing/2014/main" val="2151082113"/>
                  </a:ext>
                </a:extLst>
              </a:tr>
              <a:tr h="41902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Dyslipidaemia</a:t>
                      </a:r>
                      <a:endParaRPr lang="en-HK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33.2%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0.52</a:t>
                      </a:r>
                      <a:endParaRPr lang="en-HK" sz="16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(0.44 - 0.60)</a:t>
                      </a:r>
                      <a:endParaRPr lang="en-HK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0.46</a:t>
                      </a:r>
                      <a:endParaRPr lang="en-HK" sz="16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(0.38 - 0.55)</a:t>
                      </a:r>
                      <a:endParaRPr lang="en-HK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0.54</a:t>
                      </a:r>
                      <a:endParaRPr lang="en-HK" sz="16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(0.42 - 0.64)</a:t>
                      </a:r>
                      <a:endParaRPr lang="en-HK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0.58</a:t>
                      </a:r>
                      <a:endParaRPr lang="en-HK" sz="16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(0.47 - 0.69)</a:t>
                      </a:r>
                      <a:endParaRPr lang="en-HK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extLst>
                  <a:ext uri="{0D108BD9-81ED-4DB2-BD59-A6C34878D82A}">
                    <a16:rowId xmlns:a16="http://schemas.microsoft.com/office/drawing/2014/main" val="60053070"/>
                  </a:ext>
                </a:extLst>
              </a:tr>
              <a:tr h="41902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Arterial hypertension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52.2%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0.47</a:t>
                      </a:r>
                      <a:endParaRPr lang="en-HK" sz="16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(0.37 - 0.58)</a:t>
                      </a:r>
                      <a:endParaRPr lang="en-HK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0.60</a:t>
                      </a:r>
                      <a:endParaRPr lang="en-HK" sz="16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(0.50 - 0.69)</a:t>
                      </a:r>
                      <a:endParaRPr lang="en-HK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0.60</a:t>
                      </a:r>
                      <a:endParaRPr lang="en-HK" sz="16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(0.49 - 0.69)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0.59</a:t>
                      </a:r>
                      <a:endParaRPr lang="en-HK" sz="16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</a:rPr>
                        <a:t>(0.50 - 0.69)</a:t>
                      </a:r>
                      <a:endParaRPr lang="en-HK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extLst>
                  <a:ext uri="{0D108BD9-81ED-4DB2-BD59-A6C34878D82A}">
                    <a16:rowId xmlns:a16="http://schemas.microsoft.com/office/drawing/2014/main" val="1868736585"/>
                  </a:ext>
                </a:extLst>
              </a:tr>
              <a:tr h="41902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Sex 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48.9% female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0.81</a:t>
                      </a:r>
                      <a:endParaRPr lang="en-HK" sz="1600" b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(0.73 - 0.88)</a:t>
                      </a:r>
                      <a:endParaRPr lang="en-HK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0.65</a:t>
                      </a:r>
                      <a:endParaRPr lang="en-HK" sz="1600" b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(0.55 - 0.75)</a:t>
                      </a:r>
                      <a:endParaRPr lang="en-HK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0.65</a:t>
                      </a:r>
                      <a:endParaRPr lang="en-HK" sz="1600" b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(0.55 - 0.74)</a:t>
                      </a:r>
                      <a:endParaRPr lang="en-HK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0.66</a:t>
                      </a:r>
                      <a:endParaRPr lang="en-HK" sz="1600" b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(0.57 - 0.75)</a:t>
                      </a:r>
                      <a:endParaRPr lang="en-HK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extLst>
                  <a:ext uri="{0D108BD9-81ED-4DB2-BD59-A6C34878D82A}">
                    <a16:rowId xmlns:a16="http://schemas.microsoft.com/office/drawing/2014/main" val="1506199725"/>
                  </a:ext>
                </a:extLst>
              </a:tr>
              <a:tr h="22826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Smoking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13.6%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0.71</a:t>
                      </a:r>
                      <a:endParaRPr lang="en-HK" sz="1600" b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</a:rPr>
                        <a:t>(0.58 - 0.85)</a:t>
                      </a:r>
                      <a:endParaRPr lang="en-HK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0.47</a:t>
                      </a:r>
                      <a:endParaRPr lang="en-HK" sz="16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(0.41 - 0.56)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0.49</a:t>
                      </a:r>
                      <a:endParaRPr lang="en-HK" sz="16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(0.42 - 0.58)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0.50</a:t>
                      </a:r>
                      <a:endParaRPr lang="en-HK" sz="16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</a:rPr>
                        <a:t>(0.41 - 0.61)</a:t>
                      </a:r>
                      <a:endParaRPr lang="en-HK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546" marR="45546" marT="0" marB="0"/>
                </a:tc>
                <a:extLst>
                  <a:ext uri="{0D108BD9-81ED-4DB2-BD59-A6C34878D82A}">
                    <a16:rowId xmlns:a16="http://schemas.microsoft.com/office/drawing/2014/main" val="25162772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ach attention map was generated with one representative polar map from a patient from the test set previously unseen by the model in the development process.</a:t>
            </a:r>
            <a:endParaRPr lang="en-HK" sz="18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1A1BF0C-2482-4C1A-BAA8-1B17191723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6315" y="1600200"/>
            <a:ext cx="7058970" cy="34605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HK" altLang="en-US" sz="2800" dirty="0"/>
              <a:t>Multi-task DL is able to identify </a:t>
            </a:r>
          </a:p>
          <a:p>
            <a:pPr lvl="1"/>
            <a:r>
              <a:rPr lang="en-HK" altLang="en-US" sz="2400" dirty="0"/>
              <a:t>An impaired myocardial flow reserve (ischemia)</a:t>
            </a:r>
          </a:p>
          <a:p>
            <a:pPr lvl="1"/>
            <a:r>
              <a:rPr lang="en-HK" altLang="en-US" sz="2400" dirty="0"/>
              <a:t>cardiovascular risk factors (sex, smoking and diabetes)</a:t>
            </a:r>
            <a:endParaRPr lang="en-US" altLang="en-US" sz="2400" dirty="0"/>
          </a:p>
          <a:p>
            <a:pPr marL="0" indent="0">
              <a:buNone/>
            </a:pPr>
            <a:r>
              <a:rPr lang="en-US" altLang="en-US" sz="2800" dirty="0"/>
              <a:t>    </a:t>
            </a:r>
            <a:r>
              <a:rPr lang="en-HK" altLang="en-US" sz="2800" dirty="0"/>
              <a:t>from quantitative PET myocardial perfusion polar                maps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</TotalTime>
  <Words>653</Words>
  <Application>Microsoft Macintosh PowerPoint</Application>
  <PresentationFormat>On-screen Show (4:3)</PresentationFormat>
  <Paragraphs>11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Multi-task Deep Learning in myocardial blood flow and cardiovascular risk traits from PET myocardial perfusion imaging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Luis Eduardo Juarez-Orozco</cp:lastModifiedBy>
  <cp:revision>105</cp:revision>
  <dcterms:created xsi:type="dcterms:W3CDTF">2011-04-18T21:44:13Z</dcterms:created>
  <dcterms:modified xsi:type="dcterms:W3CDTF">2021-12-02T06:16:44Z</dcterms:modified>
</cp:coreProperties>
</file>